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46">
          <p15:clr>
            <a:srgbClr val="A4A3A4"/>
          </p15:clr>
        </p15:guide>
        <p15:guide id="2" orient="horz" pos="3243">
          <p15:clr>
            <a:srgbClr val="A4A3A4"/>
          </p15:clr>
        </p15:guide>
        <p15:guide id="3" orient="horz" pos="4748">
          <p15:clr>
            <a:srgbClr val="A4A3A4"/>
          </p15:clr>
        </p15:guide>
        <p15:guide id="4" orient="horz" pos="274">
          <p15:clr>
            <a:srgbClr val="A4A3A4"/>
          </p15:clr>
        </p15:guide>
        <p15:guide id="5" pos="391">
          <p15:clr>
            <a:srgbClr val="A4A3A4"/>
          </p15:clr>
        </p15:guide>
        <p15:guide id="6" pos="247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 autoAdjust="0"/>
    <p:restoredTop sz="90972" autoAdjust="0"/>
  </p:normalViewPr>
  <p:slideViewPr>
    <p:cSldViewPr showGuides="1">
      <p:cViewPr varScale="1">
        <p:scale>
          <a:sx n="72" d="100"/>
          <a:sy n="72" d="100"/>
        </p:scale>
        <p:origin x="3136" y="200"/>
      </p:cViewPr>
      <p:guideLst>
        <p:guide orient="horz" pos="1746"/>
        <p:guide orient="horz" pos="3243"/>
        <p:guide orient="horz" pos="4748"/>
        <p:guide orient="horz" pos="274"/>
        <p:guide pos="391"/>
        <p:guide pos="24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ABDA4-1D12-4592-AECC-DB150AAAA117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08F172-8543-4E5E-8F5D-ACD6B86D924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56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400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9107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6485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2866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2394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748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577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7921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0422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9033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763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15483-C5BB-4ECA-85B1-511E277E4B13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6569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9FA3AFA3-AA2A-D24F-97D6-0B11CD9296EB}"/>
              </a:ext>
            </a:extLst>
          </p:cNvPr>
          <p:cNvGrpSpPr/>
          <p:nvPr/>
        </p:nvGrpSpPr>
        <p:grpSpPr>
          <a:xfrm>
            <a:off x="650187" y="790638"/>
            <a:ext cx="5299093" cy="7597786"/>
            <a:chOff x="434164" y="73627"/>
            <a:chExt cx="5299093" cy="759778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99BA6C8-F2F5-DF43-9AEA-A32C4D51DF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14" t="3342"/>
            <a:stretch/>
          </p:blipFill>
          <p:spPr>
            <a:xfrm>
              <a:off x="457569" y="329543"/>
              <a:ext cx="5131671" cy="229993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A731D1C-0D1C-2646-A7B2-ECB0BA47ED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7570" y="2856232"/>
              <a:ext cx="5131670" cy="2223724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EA88754-2C4E-764F-B8D7-43DBC2A83D5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6673" y="5393560"/>
              <a:ext cx="5256584" cy="2277853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A5B3530-473E-324D-A6F6-BDBF3B057542}"/>
                </a:ext>
              </a:extLst>
            </p:cNvPr>
            <p:cNvSpPr txBox="1"/>
            <p:nvPr/>
          </p:nvSpPr>
          <p:spPr>
            <a:xfrm>
              <a:off x="443782" y="73627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4CEE7F7-03D5-4B43-811E-C08933DBF08A}"/>
                </a:ext>
              </a:extLst>
            </p:cNvPr>
            <p:cNvSpPr txBox="1"/>
            <p:nvPr/>
          </p:nvSpPr>
          <p:spPr>
            <a:xfrm>
              <a:off x="434164" y="2565394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04484B0-7454-124A-B225-5BBD8AD22D62}"/>
                </a:ext>
              </a:extLst>
            </p:cNvPr>
            <p:cNvSpPr txBox="1"/>
            <p:nvPr/>
          </p:nvSpPr>
          <p:spPr>
            <a:xfrm>
              <a:off x="443782" y="5076056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4537A16E-C862-5540-84E5-D4DFEF40BDD4}"/>
                </a:ext>
              </a:extLst>
            </p:cNvPr>
            <p:cNvSpPr/>
            <p:nvPr/>
          </p:nvSpPr>
          <p:spPr>
            <a:xfrm>
              <a:off x="654491" y="107504"/>
              <a:ext cx="91723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 cancers</a:t>
              </a:r>
              <a:endParaRPr lang="de-DE" sz="1200" dirty="0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F7610135-0D6C-EF4F-9A94-196695D885F7}"/>
                </a:ext>
              </a:extLst>
            </p:cNvPr>
            <p:cNvSpPr/>
            <p:nvPr/>
          </p:nvSpPr>
          <p:spPr>
            <a:xfrm>
              <a:off x="657827" y="2586772"/>
              <a:ext cx="1771639" cy="28661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RG-negative cancers 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D76A4B1F-CBE9-F644-BE40-83DB08A37018}"/>
                </a:ext>
              </a:extLst>
            </p:cNvPr>
            <p:cNvSpPr/>
            <p:nvPr/>
          </p:nvSpPr>
          <p:spPr>
            <a:xfrm>
              <a:off x="643101" y="5091478"/>
              <a:ext cx="1747594" cy="28661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sz="1200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RG-positive cancers </a:t>
              </a:r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B672BBE2-A967-954F-8375-3EE55FFC7107}"/>
              </a:ext>
            </a:extLst>
          </p:cNvPr>
          <p:cNvSpPr/>
          <p:nvPr/>
        </p:nvSpPr>
        <p:spPr>
          <a:xfrm>
            <a:off x="626360" y="141278"/>
            <a:ext cx="8195220" cy="498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2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nRNPA1 immunostaining and common genomic deletions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077192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22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oph Burdelski</dc:creator>
  <cp:lastModifiedBy>Microsoft Office User</cp:lastModifiedBy>
  <cp:revision>115</cp:revision>
  <dcterms:created xsi:type="dcterms:W3CDTF">2016-12-12T11:27:55Z</dcterms:created>
  <dcterms:modified xsi:type="dcterms:W3CDTF">2019-12-23T10:42:43Z</dcterms:modified>
</cp:coreProperties>
</file>